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F83E01-0134-4020-A333-8E84CDA06C5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37501A-8A81-42A5-85D0-04BC6ACC7E5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A736D8-BB45-4235-8E31-69609D72E7A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2700EF-199F-452A-B3D0-E522877253A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F37DF6-1FCF-4B5B-AD08-96EB5AF97CC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1DBCC1-6FB6-4F8E-8AD7-AB0A32C3CE7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A7059F-1AD3-44A8-A9D4-C4C8F3E8DD1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4286D9-56DC-4190-BBE2-7DCF0DB5E84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9EF45B-9269-4E01-B470-7D16ECE32F2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7DEEA3-9148-43BD-A430-DC22F52A3DD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6B12B3-6132-45BC-ABF5-E01470270B4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B10C61-74EF-4420-AC7A-FE7526C4A08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D43A03B-3174-43E7-A8B4-E93D1C30F9C0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143000" y="1295280"/>
          <a:ext cx="5105520" cy="25146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143000" y="1295280"/>
                    <a:ext cx="5105520" cy="2514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3" name=""/>
          <p:cNvGraphicFramePr/>
          <p:nvPr/>
        </p:nvGraphicFramePr>
        <p:xfrm>
          <a:off x="1143000" y="4724280"/>
          <a:ext cx="5105520" cy="243864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44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1143000" y="4724280"/>
                    <a:ext cx="5105520" cy="2438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5" name=""/>
          <p:cNvSpPr/>
          <p:nvPr/>
        </p:nvSpPr>
        <p:spPr>
          <a:xfrm>
            <a:off x="774720" y="1249200"/>
            <a:ext cx="366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a)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"/>
          <p:cNvSpPr/>
          <p:nvPr/>
        </p:nvSpPr>
        <p:spPr>
          <a:xfrm>
            <a:off x="764640" y="4724280"/>
            <a:ext cx="374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b)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>
            <a:off x="914400" y="7894800"/>
            <a:ext cx="5578560" cy="51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 representative figure depicting the segregants for tiller number (a) and panicle length (b) in the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BC</a:t>
            </a:r>
            <a:r>
              <a:rPr b="1" lang="en-US" sz="14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plants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"/>
          <p:cNvSpPr/>
          <p:nvPr/>
        </p:nvSpPr>
        <p:spPr>
          <a:xfrm>
            <a:off x="1296360" y="3780000"/>
            <a:ext cx="84204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IR 58025A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100" spc="-1" strike="noStrike">
                <a:solidFill>
                  <a:srgbClr val="000000"/>
                </a:solidFill>
                <a:latin typeface="Arial"/>
              </a:rPr>
              <a:t>O.sativa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"/>
          <p:cNvSpPr/>
          <p:nvPr/>
        </p:nvSpPr>
        <p:spPr>
          <a:xfrm>
            <a:off x="5105160" y="3809880"/>
            <a:ext cx="91368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IC 22015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100" spc="-1" strike="noStrike">
                <a:solidFill>
                  <a:srgbClr val="000000"/>
                </a:solidFill>
                <a:latin typeface="Arial"/>
              </a:rPr>
              <a:t>O.rufipogon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"/>
          <p:cNvSpPr/>
          <p:nvPr/>
        </p:nvSpPr>
        <p:spPr>
          <a:xfrm>
            <a:off x="915480" y="7162920"/>
            <a:ext cx="84204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IR 58025A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100" spc="-1" strike="noStrike">
                <a:solidFill>
                  <a:srgbClr val="000000"/>
                </a:solidFill>
                <a:latin typeface="Arial"/>
              </a:rPr>
              <a:t>O.sativa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"/>
          <p:cNvSpPr/>
          <p:nvPr/>
        </p:nvSpPr>
        <p:spPr>
          <a:xfrm>
            <a:off x="4952520" y="7162920"/>
            <a:ext cx="91368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IC 22015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100" spc="-1" strike="noStrike">
                <a:solidFill>
                  <a:srgbClr val="000000"/>
                </a:solidFill>
                <a:latin typeface="Arial"/>
              </a:rPr>
              <a:t>O.rufipogon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"/>
          <p:cNvSpPr/>
          <p:nvPr/>
        </p:nvSpPr>
        <p:spPr>
          <a:xfrm>
            <a:off x="2291040" y="3809880"/>
            <a:ext cx="418680" cy="28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BC</a:t>
            </a:r>
            <a:r>
              <a:rPr b="0" lang="en-US" sz="11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>
            <a:off x="3081600" y="3809880"/>
            <a:ext cx="418680" cy="28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BC</a:t>
            </a:r>
            <a:r>
              <a:rPr b="0" lang="en-US" sz="11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"/>
          <p:cNvSpPr/>
          <p:nvPr/>
        </p:nvSpPr>
        <p:spPr>
          <a:xfrm>
            <a:off x="3843360" y="3809880"/>
            <a:ext cx="418680" cy="28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BC</a:t>
            </a:r>
            <a:r>
              <a:rPr b="0" lang="en-US" sz="11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"/>
          <p:cNvSpPr/>
          <p:nvPr/>
        </p:nvSpPr>
        <p:spPr>
          <a:xfrm>
            <a:off x="4500720" y="3809880"/>
            <a:ext cx="418680" cy="28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BC</a:t>
            </a:r>
            <a:r>
              <a:rPr b="0" lang="en-US" sz="11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"/>
          <p:cNvSpPr/>
          <p:nvPr/>
        </p:nvSpPr>
        <p:spPr>
          <a:xfrm>
            <a:off x="1681200" y="7162920"/>
            <a:ext cx="418680" cy="28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BC</a:t>
            </a:r>
            <a:r>
              <a:rPr b="0" lang="en-US" sz="11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"/>
          <p:cNvSpPr/>
          <p:nvPr/>
        </p:nvSpPr>
        <p:spPr>
          <a:xfrm>
            <a:off x="2214720" y="7162920"/>
            <a:ext cx="418680" cy="28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BC</a:t>
            </a:r>
            <a:r>
              <a:rPr b="0" lang="en-US" sz="11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"/>
          <p:cNvSpPr/>
          <p:nvPr/>
        </p:nvSpPr>
        <p:spPr>
          <a:xfrm>
            <a:off x="2900520" y="7162920"/>
            <a:ext cx="418680" cy="28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BC</a:t>
            </a:r>
            <a:r>
              <a:rPr b="0" lang="en-US" sz="11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"/>
          <p:cNvSpPr/>
          <p:nvPr/>
        </p:nvSpPr>
        <p:spPr>
          <a:xfrm>
            <a:off x="3510000" y="7162920"/>
            <a:ext cx="418680" cy="28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BC</a:t>
            </a:r>
            <a:r>
              <a:rPr b="0" lang="en-US" sz="11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"/>
          <p:cNvSpPr/>
          <p:nvPr/>
        </p:nvSpPr>
        <p:spPr>
          <a:xfrm>
            <a:off x="4348440" y="7162920"/>
            <a:ext cx="418680" cy="28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BC</a:t>
            </a:r>
            <a:r>
              <a:rPr b="0" lang="en-US" sz="11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2-12-30T08:25:49Z</dcterms:created>
  <dc:creator>pradeep</dc:creator>
  <dc:description/>
  <dc:language>en-US</dc:language>
  <cp:lastModifiedBy> </cp:lastModifiedBy>
  <dcterms:modified xsi:type="dcterms:W3CDTF">2005-03-16T13:33:13Z</dcterms:modified>
  <cp:revision>6</cp:revision>
  <dc:subject/>
  <dc:title>PowerPoint Presentation</dc:title>
</cp:coreProperties>
</file>